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954B9-8FF1-4128-921B-A73C8D9D30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92B47-E4FE-4F66-ADE5-17C80225F6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DD44C-60D8-4C2D-B42B-BF0FF2D911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4745C-E2AE-4D76-B315-BAFFC3BF03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D5ACA-0CDE-4236-8A34-E1B777B781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BFCC2-A189-4961-87C9-13C833A755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09EB1-3321-4642-BA03-42CC36AB59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9F09D-D420-4455-B9E9-042D9D0E10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9A908-8AD4-48B4-BEF6-AF07AACD7F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1400F-FE15-44C9-A5A2-B072363673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BC59E-D55F-4598-98EC-BDC03A7119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EBD74-2490-4B8D-AFBF-E7EDAD68AD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F4C73F-D6D8-4367-AA98-1120E3B18E8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762120" y="838080"/>
            <a:ext cx="1828800" cy="6098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X-APL using both HIHG+AGRE and CHOP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" name="Straight Arrow Connector 3"/>
          <p:cNvCxnSpPr>
            <a:stCxn id="41" idx="2"/>
            <a:endCxn id="43" idx="0"/>
          </p:cNvCxnSpPr>
          <p:nvPr/>
        </p:nvCxnSpPr>
        <p:spPr>
          <a:xfrm flipH="1">
            <a:off x="723960" y="1447920"/>
            <a:ext cx="952920" cy="38124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43" name="Rectangle 5"/>
          <p:cNvSpPr/>
          <p:nvPr/>
        </p:nvSpPr>
        <p:spPr>
          <a:xfrm>
            <a:off x="76320" y="1828800"/>
            <a:ext cx="1295280" cy="83808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Calculate statistic for HIHG+AG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1828800" y="1828800"/>
            <a:ext cx="1295280" cy="83808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Calculate statistic for CHO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685800" y="2895480"/>
            <a:ext cx="2057400" cy="8384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Sum the two statisti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Calculate variance for the sum statist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380880" y="4114800"/>
            <a:ext cx="2743200" cy="76212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Calculate the joint statistic based on the sum statistic and varia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996120" y="457200"/>
            <a:ext cx="140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Joint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2"/>
          <p:cNvSpPr/>
          <p:nvPr/>
        </p:nvSpPr>
        <p:spPr>
          <a:xfrm>
            <a:off x="3886200" y="838080"/>
            <a:ext cx="1143000" cy="6098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X-APL using HIHG+AG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3"/>
          <p:cNvSpPr/>
          <p:nvPr/>
        </p:nvSpPr>
        <p:spPr>
          <a:xfrm>
            <a:off x="5257800" y="838080"/>
            <a:ext cx="1066680" cy="6098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PLINK using CHO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4"/>
          <p:cNvSpPr/>
          <p:nvPr/>
        </p:nvSpPr>
        <p:spPr>
          <a:xfrm>
            <a:off x="5257800" y="1752480"/>
            <a:ext cx="1066680" cy="8384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Calculate GC corrected statisti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5"/>
          <p:cNvSpPr/>
          <p:nvPr/>
        </p:nvSpPr>
        <p:spPr>
          <a:xfrm>
            <a:off x="4343400" y="2895480"/>
            <a:ext cx="1371600" cy="8384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Meta-analysis by combining Z scor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6"/>
          <p:cNvSpPr/>
          <p:nvPr/>
        </p:nvSpPr>
        <p:spPr>
          <a:xfrm>
            <a:off x="7162920" y="838080"/>
            <a:ext cx="1143000" cy="114300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X-APL using HIHG+AGRE as a discovery datas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7"/>
          <p:cNvSpPr/>
          <p:nvPr/>
        </p:nvSpPr>
        <p:spPr>
          <a:xfrm>
            <a:off x="7162920" y="2362320"/>
            <a:ext cx="1218960" cy="121896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PLINK using CHOP as a validation datas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8"/>
          <p:cNvSpPr/>
          <p:nvPr/>
        </p:nvSpPr>
        <p:spPr>
          <a:xfrm>
            <a:off x="7162920" y="4038480"/>
            <a:ext cx="1218960" cy="1295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SNPs with P-values &lt; 0.0025 in both analyses were defined as signific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9"/>
          <p:cNvSpPr/>
          <p:nvPr/>
        </p:nvSpPr>
        <p:spPr>
          <a:xfrm>
            <a:off x="4495680" y="4267080"/>
            <a:ext cx="1067040" cy="1295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SNPs with P-values &lt; 6.25×10</a:t>
            </a:r>
            <a:r>
              <a:rPr b="0" lang="en-US" sz="1400" spc="-1" strike="noStrike" baseline="30000">
                <a:solidFill>
                  <a:srgbClr val="ffffff"/>
                </a:solidFill>
                <a:latin typeface="Calibri"/>
              </a:rPr>
              <a:t>-6</a:t>
            </a: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 were defined as signific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0"/>
          <p:cNvSpPr/>
          <p:nvPr/>
        </p:nvSpPr>
        <p:spPr>
          <a:xfrm>
            <a:off x="1143000" y="5181480"/>
            <a:ext cx="1066680" cy="1295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SNPs with P-values &lt; 6.25×10</a:t>
            </a:r>
            <a:r>
              <a:rPr b="0" lang="en-US" sz="1400" spc="-1" strike="noStrike" baseline="30000">
                <a:solidFill>
                  <a:srgbClr val="ffffff"/>
                </a:solidFill>
                <a:latin typeface="Calibri"/>
              </a:rPr>
              <a:t>-6</a:t>
            </a:r>
            <a:r>
              <a:rPr b="0" lang="en-US" sz="1400" spc="-1" strike="noStrike">
                <a:solidFill>
                  <a:srgbClr val="ffffff"/>
                </a:solidFill>
                <a:latin typeface="Calibri"/>
              </a:rPr>
              <a:t> were defined as signific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1"/>
          <p:cNvSpPr/>
          <p:nvPr/>
        </p:nvSpPr>
        <p:spPr>
          <a:xfrm>
            <a:off x="4347720" y="457200"/>
            <a:ext cx="14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eta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2"/>
          <p:cNvSpPr/>
          <p:nvPr/>
        </p:nvSpPr>
        <p:spPr>
          <a:xfrm>
            <a:off x="6788520" y="457200"/>
            <a:ext cx="19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plication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9" name="Straight Arrow Connector 22"/>
          <p:cNvCxnSpPr>
            <a:stCxn id="41" idx="2"/>
            <a:endCxn id="44" idx="0"/>
          </p:cNvCxnSpPr>
          <p:nvPr/>
        </p:nvCxnSpPr>
        <p:spPr>
          <a:xfrm>
            <a:off x="1676520" y="1447920"/>
            <a:ext cx="800280" cy="38124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0" name="Straight Arrow Connector 24"/>
          <p:cNvCxnSpPr>
            <a:stCxn id="43" idx="2"/>
            <a:endCxn id="45" idx="0"/>
          </p:cNvCxnSpPr>
          <p:nvPr/>
        </p:nvCxnSpPr>
        <p:spPr>
          <a:xfrm>
            <a:off x="723960" y="2666880"/>
            <a:ext cx="990720" cy="22896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1" name="Straight Arrow Connector 26"/>
          <p:cNvCxnSpPr>
            <a:stCxn id="44" idx="2"/>
            <a:endCxn id="45" idx="0"/>
          </p:cNvCxnSpPr>
          <p:nvPr/>
        </p:nvCxnSpPr>
        <p:spPr>
          <a:xfrm flipH="1">
            <a:off x="1714320" y="2666880"/>
            <a:ext cx="762480" cy="22896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2" name="Straight Arrow Connector 39"/>
          <p:cNvCxnSpPr>
            <a:endCxn id="46" idx="0"/>
          </p:cNvCxnSpPr>
          <p:nvPr/>
        </p:nvCxnSpPr>
        <p:spPr>
          <a:xfrm flipH="1">
            <a:off x="1752480" y="3657600"/>
            <a:ext cx="1800" cy="45756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3" name="Straight Arrow Connector 41"/>
          <p:cNvCxnSpPr/>
          <p:nvPr/>
        </p:nvCxnSpPr>
        <p:spPr>
          <a:xfrm flipH="1">
            <a:off x="1751760" y="4724280"/>
            <a:ext cx="2520" cy="45792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4" name="Straight Arrow Connector 42"/>
          <p:cNvCxnSpPr/>
          <p:nvPr/>
        </p:nvCxnSpPr>
        <p:spPr>
          <a:xfrm flipH="1">
            <a:off x="4494960" y="1447560"/>
            <a:ext cx="2520" cy="144828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5" name="Straight Arrow Connector 45"/>
          <p:cNvCxnSpPr>
            <a:stCxn id="49" idx="2"/>
            <a:endCxn id="50" idx="0"/>
          </p:cNvCxnSpPr>
          <p:nvPr/>
        </p:nvCxnSpPr>
        <p:spPr>
          <a:xfrm>
            <a:off x="5790960" y="1447920"/>
            <a:ext cx="360" cy="30492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6" name="Straight Arrow Connector 47"/>
          <p:cNvCxnSpPr>
            <a:stCxn id="50" idx="2"/>
            <a:endCxn id="51" idx="0"/>
          </p:cNvCxnSpPr>
          <p:nvPr/>
        </p:nvCxnSpPr>
        <p:spPr>
          <a:xfrm flipH="1">
            <a:off x="5029200" y="2590920"/>
            <a:ext cx="762120" cy="30492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7" name="Straight Arrow Connector 51"/>
          <p:cNvCxnSpPr>
            <a:stCxn id="51" idx="2"/>
          </p:cNvCxnSpPr>
          <p:nvPr/>
        </p:nvCxnSpPr>
        <p:spPr>
          <a:xfrm flipH="1">
            <a:off x="5027400" y="3733920"/>
            <a:ext cx="2160" cy="53568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8" name="Straight Arrow Connector 52"/>
          <p:cNvCxnSpPr/>
          <p:nvPr/>
        </p:nvCxnSpPr>
        <p:spPr>
          <a:xfrm flipH="1">
            <a:off x="7772040" y="1905120"/>
            <a:ext cx="2160" cy="45792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9" name="Straight Arrow Connector 53"/>
          <p:cNvCxnSpPr/>
          <p:nvPr/>
        </p:nvCxnSpPr>
        <p:spPr>
          <a:xfrm flipH="1">
            <a:off x="7772040" y="3581280"/>
            <a:ext cx="2160" cy="457920"/>
          </a:xfrm>
          <a:prstGeom prst="straightConnector1">
            <a:avLst/>
          </a:prstGeom>
          <a:ln w="25560">
            <a:solidFill>
              <a:srgbClr val="4a7ebb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18T15:50:06Z</dcterms:created>
  <dc:creator>Ren-Hua Chung</dc:creator>
  <dc:description/>
  <dc:language>en-US</dc:language>
  <cp:lastModifiedBy>Ren-Hua Chung</cp:lastModifiedBy>
  <dcterms:modified xsi:type="dcterms:W3CDTF">2011-09-07T15:25:08Z</dcterms:modified>
  <cp:revision>31</cp:revision>
  <dc:subject/>
  <dc:title>Slide 1</dc:title>
</cp:coreProperties>
</file>